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2" r:id="rId2"/>
  </p:sldIdLst>
  <p:sldSz cx="6858000" cy="9906000" type="A4"/>
  <p:notesSz cx="67833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ECEC"/>
    <a:srgbClr val="D05AD0"/>
    <a:srgbClr val="01DA02"/>
    <a:srgbClr val="BC14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98" autoAdjust="0"/>
    <p:restoredTop sz="96433" autoAdjust="0"/>
  </p:normalViewPr>
  <p:slideViewPr>
    <p:cSldViewPr snapToGrid="0">
      <p:cViewPr varScale="1">
        <p:scale>
          <a:sx n="126" d="100"/>
          <a:sy n="126" d="100"/>
        </p:scale>
        <p:origin x="2808" y="20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/ad\fs\a100-projekte\Saskia%20Tauch\Bio%20Info\collaboration%20DKFZ\run%203%20&amp;%204\new%20fibi_20221004\metascape_result_metCAFs_2022112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49389380556956403"/>
          <c:y val="2.1622560365029582E-2"/>
          <c:w val="0.46882162359563051"/>
          <c:h val="0.7597071510622939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6F8-DE41-A8D4-8BB24AEB1BE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6F8-DE41-A8D4-8BB24AEB1BE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6F8-DE41-A8D4-8BB24AEB1BE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6F8-DE41-A8D4-8BB24AEB1BE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6F8-DE41-A8D4-8BB24AEB1BEC}"/>
              </c:ext>
            </c:extLst>
          </c:dPt>
          <c:dPt>
            <c:idx val="5"/>
            <c:invertIfNegative val="0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6F8-DE41-A8D4-8BB24AEB1BEC}"/>
              </c:ext>
            </c:extLst>
          </c:dPt>
          <c:dPt>
            <c:idx val="6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6F8-DE41-A8D4-8BB24AEB1BEC}"/>
              </c:ext>
            </c:extLst>
          </c:dPt>
          <c:dPt>
            <c:idx val="7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6F8-DE41-A8D4-8BB24AEB1BEC}"/>
              </c:ext>
            </c:extLst>
          </c:dPt>
          <c:dPt>
            <c:idx val="8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6F8-DE41-A8D4-8BB24AEB1BEC}"/>
              </c:ext>
            </c:extLst>
          </c:dPt>
          <c:dPt>
            <c:idx val="9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6F8-DE41-A8D4-8BB24AEB1BEC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46F8-DE41-A8D4-8BB24AEB1BEC}"/>
              </c:ext>
            </c:extLst>
          </c:dPt>
          <c:dPt>
            <c:idx val="11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46F8-DE41-A8D4-8BB24AEB1BEC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46F8-DE41-A8D4-8BB24AEB1BEC}"/>
              </c:ext>
            </c:extLst>
          </c:dPt>
          <c:dPt>
            <c:idx val="13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46F8-DE41-A8D4-8BB24AEB1BEC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46F8-DE41-A8D4-8BB24AEB1BEC}"/>
              </c:ext>
            </c:extLst>
          </c:dPt>
          <c:dPt>
            <c:idx val="15"/>
            <c:invertIfNegative val="0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46F8-DE41-A8D4-8BB24AEB1BEC}"/>
              </c:ext>
            </c:extLst>
          </c:dPt>
          <c:cat>
            <c:strRef>
              <c:f>Sheet1!$D$2:$D$17</c:f>
              <c:strCache>
                <c:ptCount val="16"/>
                <c:pt idx="0">
                  <c:v>GO:0035239 Tube morphogenesis</c:v>
                </c:pt>
                <c:pt idx="1">
                  <c:v>GO:0007423 Sensory organ development</c:v>
                </c:pt>
                <c:pt idx="2">
                  <c:v>GO:1905940 Negative regulation of gonad development</c:v>
                </c:pt>
                <c:pt idx="3">
                  <c:v>GO:0007389 Pattern specification process</c:v>
                </c:pt>
                <c:pt idx="4">
                  <c:v>GO:0007507 Heart development</c:v>
                </c:pt>
                <c:pt idx="5">
                  <c:v>GO:0010811 Positive regulation of cell-substrate adhesion</c:v>
                </c:pt>
                <c:pt idx="6">
                  <c:v>GO:0030198 Extracellular matrix organization</c:v>
                </c:pt>
                <c:pt idx="7">
                  <c:v>GO:0006935 Chemotaxis</c:v>
                </c:pt>
                <c:pt idx="8">
                  <c:v>GO:0048260 Positive regulation of receptor-mediated endocytosis</c:v>
                </c:pt>
                <c:pt idx="9">
                  <c:v>GO:1901342 Regulation of vasculature development</c:v>
                </c:pt>
                <c:pt idx="10">
                  <c:v>GO:0098609 Cell-cell adhesion</c:v>
                </c:pt>
                <c:pt idx="11">
                  <c:v>GO:0001817 Regulation of cytokine production</c:v>
                </c:pt>
                <c:pt idx="12">
                  <c:v>GO:0031016 Pancreas development</c:v>
                </c:pt>
                <c:pt idx="13">
                  <c:v>GO:0045638 Negative regulation of myeloid cell differentiation</c:v>
                </c:pt>
                <c:pt idx="14">
                  <c:v>GO:2001233 Regulation of apoptotic signaling pathway</c:v>
                </c:pt>
                <c:pt idx="15">
                  <c:v>GO:0070661 Leukocyte proliferation</c:v>
                </c:pt>
              </c:strCache>
            </c:strRef>
          </c:cat>
          <c:val>
            <c:numRef>
              <c:f>Sheet1!$E$2:$E$17</c:f>
              <c:numCache>
                <c:formatCode>General</c:formatCode>
                <c:ptCount val="16"/>
                <c:pt idx="0">
                  <c:v>8.2759570883000002</c:v>
                </c:pt>
                <c:pt idx="1">
                  <c:v>7.3499387790000004</c:v>
                </c:pt>
                <c:pt idx="2">
                  <c:v>6.5729278714000001</c:v>
                </c:pt>
                <c:pt idx="3">
                  <c:v>5.8421439685000003</c:v>
                </c:pt>
                <c:pt idx="4">
                  <c:v>5.8175920855000003</c:v>
                </c:pt>
                <c:pt idx="5">
                  <c:v>5.4078260389999997</c:v>
                </c:pt>
                <c:pt idx="6">
                  <c:v>4.6728491978999998</c:v>
                </c:pt>
                <c:pt idx="7">
                  <c:v>4.6328224240000004</c:v>
                </c:pt>
                <c:pt idx="8">
                  <c:v>4.4197736919999997</c:v>
                </c:pt>
                <c:pt idx="9">
                  <c:v>4.3534734426000004</c:v>
                </c:pt>
                <c:pt idx="10">
                  <c:v>4.1695738664000004</c:v>
                </c:pt>
                <c:pt idx="11">
                  <c:v>3.9117559665999999</c:v>
                </c:pt>
                <c:pt idx="12">
                  <c:v>3.8242516133</c:v>
                </c:pt>
                <c:pt idx="13">
                  <c:v>3.7496552205999998</c:v>
                </c:pt>
                <c:pt idx="14">
                  <c:v>3.6756380144</c:v>
                </c:pt>
                <c:pt idx="15">
                  <c:v>3.5709973758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46F8-DE41-A8D4-8BB24AEB1B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overlap val="11"/>
        <c:axId val="653456904"/>
        <c:axId val="653454552"/>
      </c:barChart>
      <c:catAx>
        <c:axId val="65345690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653454552"/>
        <c:crosses val="autoZero"/>
        <c:auto val="0"/>
        <c:lblAlgn val="ctr"/>
        <c:lblOffset val="100"/>
        <c:noMultiLvlLbl val="0"/>
      </c:catAx>
      <c:valAx>
        <c:axId val="653454552"/>
        <c:scaling>
          <c:orientation val="minMax"/>
          <c:max val="9"/>
          <c:min val="0"/>
        </c:scaling>
        <c:delete val="0"/>
        <c:axPos val="t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10(P)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64862425808381807"/>
              <c:y val="0.851351040420617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ctr" rtl="0">
                <a:defRPr sz="6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653456904"/>
        <c:crosses val="autoZero"/>
        <c:crossBetween val="between"/>
        <c:majorUnit val="5"/>
        <c:min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235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ACCED-A51B-483E-80EA-C58192E70185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3613" y="1241425"/>
            <a:ext cx="23161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339" y="4777194"/>
            <a:ext cx="542671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235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18F4EB-17FA-4F5B-82DA-9E6943BA933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54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045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7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603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447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68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536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5418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406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08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636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653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29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337331" y="3575065"/>
            <a:ext cx="2447349" cy="2058575"/>
            <a:chOff x="203044" y="4055940"/>
            <a:chExt cx="2447349" cy="2058575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044" y="4090625"/>
              <a:ext cx="2447349" cy="202389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93404" y="4055940"/>
              <a:ext cx="5521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aa3</a:t>
              </a:r>
              <a:endParaRPr lang="en-GB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3" t="30803" r="17605" b="38194"/>
          <a:stretch/>
        </p:blipFill>
        <p:spPr>
          <a:xfrm>
            <a:off x="669477" y="6497773"/>
            <a:ext cx="5701215" cy="3081701"/>
          </a:xfrm>
          <a:prstGeom prst="rect">
            <a:avLst/>
          </a:prstGeom>
        </p:spPr>
      </p:pic>
      <p:grpSp>
        <p:nvGrpSpPr>
          <p:cNvPr id="17" name="Group 16"/>
          <p:cNvGrpSpPr/>
          <p:nvPr/>
        </p:nvGrpSpPr>
        <p:grpSpPr>
          <a:xfrm>
            <a:off x="3061309" y="844008"/>
            <a:ext cx="3925600" cy="2731057"/>
            <a:chOff x="-1076471" y="567519"/>
            <a:chExt cx="33107659" cy="15733060"/>
          </a:xfrm>
        </p:grpSpPr>
        <p:graphicFrame>
          <p:nvGraphicFramePr>
            <p:cNvPr id="18" name="Chart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12517788"/>
                </p:ext>
              </p:extLst>
            </p:nvPr>
          </p:nvGraphicFramePr>
          <p:xfrm>
            <a:off x="-1076471" y="567519"/>
            <a:ext cx="33107659" cy="157330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9" name="TextBox 1"/>
            <p:cNvSpPr txBox="1"/>
            <p:nvPr/>
          </p:nvSpPr>
          <p:spPr>
            <a:xfrm>
              <a:off x="23480732" y="13209855"/>
              <a:ext cx="387262" cy="755724"/>
            </a:xfrm>
            <a:prstGeom prst="rect">
              <a:avLst/>
            </a:prstGeom>
            <a:noFill/>
            <a:ln>
              <a:noFill/>
            </a:ln>
            <a:effectLst/>
          </p:spPr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190843" y="281491"/>
            <a:ext cx="2122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</a:t>
            </a:r>
            <a:r>
              <a:rPr lang="de-DE" dirty="0"/>
              <a:t>4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203200" y="6168582"/>
            <a:ext cx="2122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</a:t>
            </a:r>
            <a:r>
              <a:rPr lang="de-DE" dirty="0"/>
              <a:t>5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134236" y="796653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34236" y="3331745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9923" y="6727761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398287" y="6733360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648401" y="935152"/>
            <a:ext cx="2059905" cy="4030780"/>
            <a:chOff x="121321" y="559653"/>
            <a:chExt cx="2059905" cy="4030780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4624" y="559653"/>
              <a:ext cx="1886602" cy="3386208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6"/>
            <a:srcRect t="46390" b="1"/>
            <a:stretch/>
          </p:blipFill>
          <p:spPr>
            <a:xfrm>
              <a:off x="121321" y="3904401"/>
              <a:ext cx="2059905" cy="686032"/>
            </a:xfrm>
            <a:prstGeom prst="rect">
              <a:avLst/>
            </a:prstGeom>
          </p:spPr>
        </p:pic>
      </p:grpSp>
      <p:sp>
        <p:nvSpPr>
          <p:cNvPr id="30" name="TextBox 29"/>
          <p:cNvSpPr txBox="1"/>
          <p:nvPr/>
        </p:nvSpPr>
        <p:spPr>
          <a:xfrm>
            <a:off x="279923" y="796652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014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</Words>
  <Application>Microsoft Macintosh PowerPoint</Application>
  <PresentationFormat>A4-Papier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uch, Saskia</dc:creator>
  <cp:lastModifiedBy>Peter Angel</cp:lastModifiedBy>
  <cp:revision>224</cp:revision>
  <cp:lastPrinted>2024-01-12T09:55:11Z</cp:lastPrinted>
  <dcterms:created xsi:type="dcterms:W3CDTF">2023-06-21T13:26:00Z</dcterms:created>
  <dcterms:modified xsi:type="dcterms:W3CDTF">2024-11-27T13:27:10Z</dcterms:modified>
</cp:coreProperties>
</file>